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9" r:id="rId3"/>
    <p:sldId id="261" r:id="rId4"/>
    <p:sldId id="260" r:id="rId5"/>
    <p:sldId id="258" r:id="rId6"/>
    <p:sldId id="257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09" d="100"/>
          <a:sy n="109" d="100"/>
        </p:scale>
        <p:origin x="534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54B8B0-05FE-EA12-25AF-CD1D70FAC7A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D42A37C-E3D6-264B-432D-84136A8EB60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CB556EE-2944-F367-8925-83D400C91C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52F85B-D268-4721-A1E1-87C957B4CECB}" type="datetimeFigureOut">
              <a:rPr lang="en-US" smtClean="0"/>
              <a:t>5/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D5B6F80-E414-2E87-5687-759FFEFCE2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8FFCFE6-6D46-D6BE-1C68-906D303931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52B570-D069-4841-B1E3-CE345BCE61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54552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F1C2A3-4F6D-DBFD-B902-4F68C13B924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FF93132-EC87-FA26-55B9-4B9E05675C5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5B61DB8-C347-560F-EAF9-C28F4B7FD4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52F85B-D268-4721-A1E1-87C957B4CECB}" type="datetimeFigureOut">
              <a:rPr lang="en-US" smtClean="0"/>
              <a:t>5/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1FA8D10-0648-B366-5CD3-4254C64FE2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BD312A5-26E8-1768-AA39-A518F5378A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52B570-D069-4841-B1E3-CE345BCE61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32585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868D803-139F-6F98-ED0D-0AFCEF17FA5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3322FFD-2246-48B2-8D0B-9577AF02F6D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D5CA3A8-9193-9693-DE96-36CA40D76C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52F85B-D268-4721-A1E1-87C957B4CECB}" type="datetimeFigureOut">
              <a:rPr lang="en-US" smtClean="0"/>
              <a:t>5/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7226B20-2AB9-3D61-83DB-7A01622DDE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50856BD-087C-27F0-A0FC-FF7FF583FB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52B570-D069-4841-B1E3-CE345BCE61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43317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D8B97AE-3B7E-3C21-9B08-602F5294E89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FF6A0C0-857C-1C68-29E0-DE8A9294C95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F6E97CF-7588-B6E2-F288-FAADA4D267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52F85B-D268-4721-A1E1-87C957B4CECB}" type="datetimeFigureOut">
              <a:rPr lang="en-US" smtClean="0"/>
              <a:t>5/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99ECF31-44EA-6DA5-F71F-4355974B76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57F5C4C-FD01-1B64-EC6C-1935C2B704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52B570-D069-4841-B1E3-CE345BCE61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39384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F09A955-BF1A-CB47-413C-5856F72F81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E517BBD-1ACC-3A76-D903-686D3DD2A28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7253863-7730-DA40-2A9B-2EBBFCB442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52F85B-D268-4721-A1E1-87C957B4CECB}" type="datetimeFigureOut">
              <a:rPr lang="en-US" smtClean="0"/>
              <a:t>5/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9A69133-1B92-84A7-C29D-2A7D4F9475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8C2780E-905F-4BD2-6B7F-5E1055C7B7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52B570-D069-4841-B1E3-CE345BCE61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99515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7911974-2034-47F7-4C14-73ABDBAD624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2FB5E2C-859F-3B43-5426-78FA47F5F54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82D615D-D55A-2835-EA2B-4BAFC09EB02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F2A2EF8-DFB1-EB33-C6BF-31066E561F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52F85B-D268-4721-A1E1-87C957B4CECB}" type="datetimeFigureOut">
              <a:rPr lang="en-US" smtClean="0"/>
              <a:t>5/6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CAA3108-6405-04D6-F510-E0BD9C2097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0E70A27-1189-02F0-1A53-1E76D6A85B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52B570-D069-4841-B1E3-CE345BCE61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97351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E6CEE1D-7E2D-4286-01E4-7B3EF16AF0E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E54C52F-6B4E-F962-959C-50714904A9A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CCBA6C4-49F0-F8CB-A5FA-190A580D8B3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6459D8E-DDB7-0D91-03F6-E0D4F52541E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4F1DBBF-2B1F-15BD-D1BD-E5491EBB7BD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EAFCA3C-D156-22A4-9819-57909E0051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52F85B-D268-4721-A1E1-87C957B4CECB}" type="datetimeFigureOut">
              <a:rPr lang="en-US" smtClean="0"/>
              <a:t>5/6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680938D-2CE2-CC57-F300-A09CBE56F6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23D1AED-F676-4754-7F14-EB2FD3BAF7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52B570-D069-4841-B1E3-CE345BCE61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80884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B1A623-5931-7E33-2630-03B27E569A5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9521C4E-114A-C412-9A95-272DD679DF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52F85B-D268-4721-A1E1-87C957B4CECB}" type="datetimeFigureOut">
              <a:rPr lang="en-US" smtClean="0"/>
              <a:t>5/6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6F09F0B-B3DC-39A1-7ACC-77D3443A75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35DDD6C-6DD7-2422-6A73-AA881114C2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52B570-D069-4841-B1E3-CE345BCE61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88067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D310035-0E19-3FA9-D220-61C433CCFA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52F85B-D268-4721-A1E1-87C957B4CECB}" type="datetimeFigureOut">
              <a:rPr lang="en-US" smtClean="0"/>
              <a:t>5/6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A8714B2-BFA5-04EF-DD22-131D6097B4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F42EA00-7046-C5F1-77D6-4EB497F4C5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52B570-D069-4841-B1E3-CE345BCE61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94021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77EFC6E-67BA-3909-6E72-C045677105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F0EB47F-4E37-B4A8-0A91-679BF56EBD1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1D6BE2D-013E-B5B5-A0DD-6F1C11E218B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D0002AC-5D87-218D-6478-1EFAA0FE25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52F85B-D268-4721-A1E1-87C957B4CECB}" type="datetimeFigureOut">
              <a:rPr lang="en-US" smtClean="0"/>
              <a:t>5/6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48CD170-30CB-079C-5D73-564DBD895C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CED1DB9-3CAC-27CD-F234-1001CF9AD0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52B570-D069-4841-B1E3-CE345BCE61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79976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5005D5-3A20-81A0-76F5-310BB8B425B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645405E-4EC6-0E1E-895B-9B2B9755E51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87481CC-2464-73DE-853A-C010779D557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54386BE-68E9-4A29-7A89-8B6B5FA87B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52F85B-D268-4721-A1E1-87C957B4CECB}" type="datetimeFigureOut">
              <a:rPr lang="en-US" smtClean="0"/>
              <a:t>5/6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63662CD-442E-D09F-2C84-F44DCCB9BB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0F70D3D-3246-9885-87E4-EA586E7E02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52B570-D069-4841-B1E3-CE345BCE61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36812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656F226-86F9-3072-9C13-9A1C92211EE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264AAE8-433F-FAE7-065F-A70860B0C7E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4EBEAC7-3006-A052-FCE6-50CB4D9FBEF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52F85B-D268-4721-A1E1-87C957B4CECB}" type="datetimeFigureOut">
              <a:rPr lang="en-US" smtClean="0"/>
              <a:t>5/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7AA1A04-9512-239A-C286-0D64AC535EE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FC5E836-31CF-15EF-5BF9-32A2DB872F5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52B570-D069-4841-B1E3-CE345BCE61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62535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ti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9C4D2268-4082-A454-9F80-54CAD0A688BD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18631" b="23010"/>
          <a:stretch/>
        </p:blipFill>
        <p:spPr>
          <a:xfrm>
            <a:off x="1940523" y="3480131"/>
            <a:ext cx="7200900" cy="522514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AC3CE443-98EB-A3DF-9A83-B753CED922A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940523" y="4127800"/>
            <a:ext cx="7200899" cy="581025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50E27179-4F8B-5510-E68D-BAA34F18DE66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37122" b="-2701"/>
          <a:stretch/>
        </p:blipFill>
        <p:spPr>
          <a:xfrm>
            <a:off x="1940525" y="2062274"/>
            <a:ext cx="7200900" cy="596047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AD4C5868-98C9-C7D8-3A4E-2A28DAA383EB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-949" r="2153"/>
          <a:stretch/>
        </p:blipFill>
        <p:spPr>
          <a:xfrm>
            <a:off x="1960911" y="2783476"/>
            <a:ext cx="7114189" cy="571500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CE227336-7409-23D5-BA29-63DDC1124B38}"/>
              </a:ext>
            </a:extLst>
          </p:cNvPr>
          <p:cNvSpPr txBox="1"/>
          <p:nvPr/>
        </p:nvSpPr>
        <p:spPr>
          <a:xfrm>
            <a:off x="9063612" y="2095572"/>
            <a:ext cx="10869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TP5F1A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567C0128-3230-3596-E39E-9AA019BA5A74}"/>
              </a:ext>
            </a:extLst>
          </p:cNvPr>
          <p:cNvSpPr txBox="1"/>
          <p:nvPr/>
        </p:nvSpPr>
        <p:spPr>
          <a:xfrm>
            <a:off x="9075099" y="2889945"/>
            <a:ext cx="99883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ATP5F1B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A471D152-0A79-E20D-7501-BC40A9C14957}"/>
              </a:ext>
            </a:extLst>
          </p:cNvPr>
          <p:cNvSpPr txBox="1"/>
          <p:nvPr/>
        </p:nvSpPr>
        <p:spPr>
          <a:xfrm>
            <a:off x="9063613" y="3586600"/>
            <a:ext cx="8362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ATP5PO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3B411DCB-C6D5-7AFF-DBBC-774D9A3A877B}"/>
              </a:ext>
            </a:extLst>
          </p:cNvPr>
          <p:cNvSpPr txBox="1"/>
          <p:nvPr/>
        </p:nvSpPr>
        <p:spPr>
          <a:xfrm>
            <a:off x="9063613" y="4109114"/>
            <a:ext cx="40749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S</a:t>
            </a:r>
            <a:endParaRPr kumimoji="0" 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9CD0BB07-48CE-EEA5-DED5-45EA51D1BF78}"/>
              </a:ext>
            </a:extLst>
          </p:cNvPr>
          <p:cNvSpPr txBox="1"/>
          <p:nvPr/>
        </p:nvSpPr>
        <p:spPr>
          <a:xfrm>
            <a:off x="1960911" y="1660120"/>
            <a:ext cx="1131264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oband 1</a:t>
            </a:r>
            <a:endParaRPr kumimoji="0" 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C454CAAF-FCF4-71C7-CC9F-45663191B444}"/>
              </a:ext>
            </a:extLst>
          </p:cNvPr>
          <p:cNvSpPr txBox="1"/>
          <p:nvPr/>
        </p:nvSpPr>
        <p:spPr>
          <a:xfrm>
            <a:off x="5853400" y="1669463"/>
            <a:ext cx="1046415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Proband 4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9B0499EA-5697-A7D4-CF56-B0F17B409AE5}"/>
              </a:ext>
            </a:extLst>
          </p:cNvPr>
          <p:cNvSpPr txBox="1"/>
          <p:nvPr/>
        </p:nvSpPr>
        <p:spPr>
          <a:xfrm>
            <a:off x="5034725" y="1669463"/>
            <a:ext cx="102317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Proband 6</a:t>
            </a:r>
          </a:p>
        </p:txBody>
      </p: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C8865127-E579-0064-0DA1-BA05F08A506B}"/>
              </a:ext>
            </a:extLst>
          </p:cNvPr>
          <p:cNvCxnSpPr>
            <a:cxnSpLocks/>
          </p:cNvCxnSpPr>
          <p:nvPr/>
        </p:nvCxnSpPr>
        <p:spPr>
          <a:xfrm flipV="1">
            <a:off x="2905572" y="1937116"/>
            <a:ext cx="1935786" cy="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E5465C42-B2D9-9AFB-17D0-82BF6E707C08}"/>
              </a:ext>
            </a:extLst>
          </p:cNvPr>
          <p:cNvCxnSpPr>
            <a:cxnSpLocks/>
          </p:cNvCxnSpPr>
          <p:nvPr/>
        </p:nvCxnSpPr>
        <p:spPr>
          <a:xfrm>
            <a:off x="6869396" y="1907277"/>
            <a:ext cx="1842679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30">
            <a:extLst>
              <a:ext uri="{FF2B5EF4-FFF2-40B4-BE49-F238E27FC236}">
                <a16:creationId xmlns:a16="http://schemas.microsoft.com/office/drawing/2014/main" id="{58345EDD-FEC7-D419-24DF-C2CAAC78D33F}"/>
              </a:ext>
            </a:extLst>
          </p:cNvPr>
          <p:cNvSpPr txBox="1"/>
          <p:nvPr/>
        </p:nvSpPr>
        <p:spPr>
          <a:xfrm>
            <a:off x="3201378" y="1660117"/>
            <a:ext cx="163998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ntrol fibroblasts</a:t>
            </a:r>
            <a:endParaRPr kumimoji="0" 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771177E4-F7E6-026F-DDFC-D6A9CF40DDD6}"/>
              </a:ext>
            </a:extLst>
          </p:cNvPr>
          <p:cNvSpPr txBox="1"/>
          <p:nvPr/>
        </p:nvSpPr>
        <p:spPr>
          <a:xfrm>
            <a:off x="7082329" y="1624195"/>
            <a:ext cx="1629746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Control fibroblasts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7B3B0EBC-B232-3184-A0E0-101BD7A80084}"/>
              </a:ext>
            </a:extLst>
          </p:cNvPr>
          <p:cNvSpPr txBox="1"/>
          <p:nvPr/>
        </p:nvSpPr>
        <p:spPr>
          <a:xfrm>
            <a:off x="1143000" y="747346"/>
            <a:ext cx="1060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6C</a:t>
            </a:r>
          </a:p>
        </p:txBody>
      </p:sp>
    </p:spTree>
    <p:extLst>
      <p:ext uri="{BB962C8B-B14F-4D97-AF65-F5344CB8AC3E}">
        <p14:creationId xmlns:p14="http://schemas.microsoft.com/office/powerpoint/2010/main" val="116165002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extBox 12">
            <a:extLst>
              <a:ext uri="{FF2B5EF4-FFF2-40B4-BE49-F238E27FC236}">
                <a16:creationId xmlns:a16="http://schemas.microsoft.com/office/drawing/2014/main" id="{2B67243E-6975-FC3F-7C76-3CBD422955BF}"/>
              </a:ext>
            </a:extLst>
          </p:cNvPr>
          <p:cNvSpPr txBox="1"/>
          <p:nvPr/>
        </p:nvSpPr>
        <p:spPr>
          <a:xfrm>
            <a:off x="5430023" y="2876146"/>
            <a:ext cx="125270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1" i="0" u="none" strike="noStrike" kern="1200" cap="none" spc="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ATP5F1B</a:t>
            </a:r>
          </a:p>
        </p:txBody>
      </p:sp>
      <p:pic>
        <p:nvPicPr>
          <p:cNvPr id="14" name="Picture 13" descr="A black lines on a white background&#10;&#10;AI-generated content may be incorrect.">
            <a:extLst>
              <a:ext uri="{FF2B5EF4-FFF2-40B4-BE49-F238E27FC236}">
                <a16:creationId xmlns:a16="http://schemas.microsoft.com/office/drawing/2014/main" id="{ECABCDFA-4A66-68EE-7F51-D4CE2EEE873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668" t="39345" r="12435" b="5344"/>
          <a:stretch/>
        </p:blipFill>
        <p:spPr>
          <a:xfrm>
            <a:off x="1524575" y="1386063"/>
            <a:ext cx="8459085" cy="5201758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73766927-3EE3-E5DF-B0EE-CEC23A60FE95}"/>
              </a:ext>
            </a:extLst>
          </p:cNvPr>
          <p:cNvSpPr txBox="1"/>
          <p:nvPr/>
        </p:nvSpPr>
        <p:spPr>
          <a:xfrm>
            <a:off x="2208340" y="558917"/>
            <a:ext cx="1131264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oband 1</a:t>
            </a:r>
            <a:endParaRPr kumimoji="0" 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7597E2F6-B490-52DE-5B5B-3F7B90D0FAEF}"/>
              </a:ext>
            </a:extLst>
          </p:cNvPr>
          <p:cNvSpPr txBox="1"/>
          <p:nvPr/>
        </p:nvSpPr>
        <p:spPr>
          <a:xfrm>
            <a:off x="6100829" y="568260"/>
            <a:ext cx="1046415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Proband 4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3ED6B808-5D28-C70C-DB97-0FB9BECE1B55}"/>
              </a:ext>
            </a:extLst>
          </p:cNvPr>
          <p:cNvSpPr txBox="1"/>
          <p:nvPr/>
        </p:nvSpPr>
        <p:spPr>
          <a:xfrm>
            <a:off x="5282154" y="568260"/>
            <a:ext cx="102317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Proband 6</a:t>
            </a:r>
          </a:p>
        </p:txBody>
      </p:sp>
      <p:cxnSp>
        <p:nvCxnSpPr>
          <p:cNvPr id="5" name="Straight Connector 4">
            <a:extLst>
              <a:ext uri="{FF2B5EF4-FFF2-40B4-BE49-F238E27FC236}">
                <a16:creationId xmlns:a16="http://schemas.microsoft.com/office/drawing/2014/main" id="{3D344F56-D59C-B59B-C926-7F413E3E8237}"/>
              </a:ext>
            </a:extLst>
          </p:cNvPr>
          <p:cNvCxnSpPr>
            <a:cxnSpLocks/>
          </p:cNvCxnSpPr>
          <p:nvPr/>
        </p:nvCxnSpPr>
        <p:spPr>
          <a:xfrm flipV="1">
            <a:off x="3153001" y="835913"/>
            <a:ext cx="1935786" cy="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id="{556ED0F7-DA05-B5E2-5AB6-A534CE29D07D}"/>
              </a:ext>
            </a:extLst>
          </p:cNvPr>
          <p:cNvCxnSpPr>
            <a:cxnSpLocks/>
          </p:cNvCxnSpPr>
          <p:nvPr/>
        </p:nvCxnSpPr>
        <p:spPr>
          <a:xfrm>
            <a:off x="7214868" y="835913"/>
            <a:ext cx="1842679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>
            <a:extLst>
              <a:ext uri="{FF2B5EF4-FFF2-40B4-BE49-F238E27FC236}">
                <a16:creationId xmlns:a16="http://schemas.microsoft.com/office/drawing/2014/main" id="{4579B20F-BE03-E804-E1DB-B8E7466F62DA}"/>
              </a:ext>
            </a:extLst>
          </p:cNvPr>
          <p:cNvSpPr txBox="1"/>
          <p:nvPr/>
        </p:nvSpPr>
        <p:spPr>
          <a:xfrm>
            <a:off x="3448807" y="558914"/>
            <a:ext cx="163998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ntrol fibroblasts</a:t>
            </a:r>
            <a:endParaRPr kumimoji="0" 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0618D4FB-5822-3684-4455-19440E2BEC75}"/>
              </a:ext>
            </a:extLst>
          </p:cNvPr>
          <p:cNvSpPr txBox="1"/>
          <p:nvPr/>
        </p:nvSpPr>
        <p:spPr>
          <a:xfrm>
            <a:off x="7329758" y="522992"/>
            <a:ext cx="1629746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Control fibroblasts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E4A294AA-C879-9710-D951-39B3CF0075E7}"/>
              </a:ext>
            </a:extLst>
          </p:cNvPr>
          <p:cNvSpPr/>
          <p:nvPr/>
        </p:nvSpPr>
        <p:spPr>
          <a:xfrm>
            <a:off x="2208340" y="3214215"/>
            <a:ext cx="7198703" cy="52536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69E18CCE-2A1C-E934-0C59-A64FD87F6E9B}"/>
              </a:ext>
            </a:extLst>
          </p:cNvPr>
          <p:cNvSpPr txBox="1"/>
          <p:nvPr/>
        </p:nvSpPr>
        <p:spPr>
          <a:xfrm>
            <a:off x="9415836" y="3292229"/>
            <a:ext cx="124279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1" i="0" u="none" strike="noStrike" kern="1200" cap="none" spc="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ATP5F1B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47A76434-DACB-CEA2-7D4C-49D25AA3DBB2}"/>
              </a:ext>
            </a:extLst>
          </p:cNvPr>
          <p:cNvSpPr txBox="1"/>
          <p:nvPr/>
        </p:nvSpPr>
        <p:spPr>
          <a:xfrm>
            <a:off x="1564659" y="1362509"/>
            <a:ext cx="6062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50-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8E5A92E8-BCF7-AF93-3232-5BACCAA2EB17}"/>
              </a:ext>
            </a:extLst>
          </p:cNvPr>
          <p:cNvSpPr txBox="1"/>
          <p:nvPr/>
        </p:nvSpPr>
        <p:spPr>
          <a:xfrm>
            <a:off x="1564659" y="1731841"/>
            <a:ext cx="6062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50-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272791FD-5E09-E327-D959-5827B42B4ED0}"/>
              </a:ext>
            </a:extLst>
          </p:cNvPr>
          <p:cNvSpPr txBox="1"/>
          <p:nvPr/>
        </p:nvSpPr>
        <p:spPr>
          <a:xfrm>
            <a:off x="1569055" y="2142148"/>
            <a:ext cx="6062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00-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515298EB-CD2C-191B-A0CA-C1FC29990965}"/>
              </a:ext>
            </a:extLst>
          </p:cNvPr>
          <p:cNvSpPr txBox="1"/>
          <p:nvPr/>
        </p:nvSpPr>
        <p:spPr>
          <a:xfrm>
            <a:off x="1681679" y="2511480"/>
            <a:ext cx="489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75-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8DA9D2C0-CF24-B12B-49B4-4CC070173091}"/>
              </a:ext>
            </a:extLst>
          </p:cNvPr>
          <p:cNvSpPr txBox="1"/>
          <p:nvPr/>
        </p:nvSpPr>
        <p:spPr>
          <a:xfrm>
            <a:off x="1681679" y="3428702"/>
            <a:ext cx="489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50-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4745823B-7D5A-B06F-651E-6E8F70D96640}"/>
              </a:ext>
            </a:extLst>
          </p:cNvPr>
          <p:cNvSpPr txBox="1"/>
          <p:nvPr/>
        </p:nvSpPr>
        <p:spPr>
          <a:xfrm>
            <a:off x="1681679" y="4111543"/>
            <a:ext cx="489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37-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96BF0F1D-1C4B-73EC-FCA0-5090B4B3CF16}"/>
              </a:ext>
            </a:extLst>
          </p:cNvPr>
          <p:cNvSpPr txBox="1"/>
          <p:nvPr/>
        </p:nvSpPr>
        <p:spPr>
          <a:xfrm>
            <a:off x="1692283" y="5293946"/>
            <a:ext cx="489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5-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C7DB343B-DBDF-143D-C5AD-E4335CB301DC}"/>
              </a:ext>
            </a:extLst>
          </p:cNvPr>
          <p:cNvSpPr txBox="1"/>
          <p:nvPr/>
        </p:nvSpPr>
        <p:spPr>
          <a:xfrm>
            <a:off x="1681679" y="5931144"/>
            <a:ext cx="489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0-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ECF386C4-3717-B785-53A1-60C1E581F555}"/>
              </a:ext>
            </a:extLst>
          </p:cNvPr>
          <p:cNvSpPr txBox="1"/>
          <p:nvPr/>
        </p:nvSpPr>
        <p:spPr>
          <a:xfrm>
            <a:off x="1545665" y="799991"/>
            <a:ext cx="5421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kDa</a:t>
            </a:r>
          </a:p>
        </p:txBody>
      </p:sp>
    </p:spTree>
    <p:extLst>
      <p:ext uri="{BB962C8B-B14F-4D97-AF65-F5344CB8AC3E}">
        <p14:creationId xmlns:p14="http://schemas.microsoft.com/office/powerpoint/2010/main" val="215105006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137B0312-C697-39AE-43FE-2046B74B7DFC}"/>
              </a:ext>
            </a:extLst>
          </p:cNvPr>
          <p:cNvSpPr txBox="1"/>
          <p:nvPr/>
        </p:nvSpPr>
        <p:spPr>
          <a:xfrm>
            <a:off x="2343311" y="319752"/>
            <a:ext cx="1131264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oband 1</a:t>
            </a:r>
            <a:endParaRPr kumimoji="0" 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1E9D0B7A-1776-65A8-56C0-429967FD234F}"/>
              </a:ext>
            </a:extLst>
          </p:cNvPr>
          <p:cNvSpPr txBox="1"/>
          <p:nvPr/>
        </p:nvSpPr>
        <p:spPr>
          <a:xfrm>
            <a:off x="6235800" y="329095"/>
            <a:ext cx="1046415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Proband 4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17CA04DF-C358-024E-1820-9865804F7B0C}"/>
              </a:ext>
            </a:extLst>
          </p:cNvPr>
          <p:cNvSpPr txBox="1"/>
          <p:nvPr/>
        </p:nvSpPr>
        <p:spPr>
          <a:xfrm>
            <a:off x="5417125" y="329095"/>
            <a:ext cx="102317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Proband 6</a:t>
            </a:r>
          </a:p>
        </p:txBody>
      </p:sp>
      <p:cxnSp>
        <p:nvCxnSpPr>
          <p:cNvPr id="5" name="Straight Connector 4">
            <a:extLst>
              <a:ext uri="{FF2B5EF4-FFF2-40B4-BE49-F238E27FC236}">
                <a16:creationId xmlns:a16="http://schemas.microsoft.com/office/drawing/2014/main" id="{71C29744-93D6-50BA-6D04-43ACF587CF77}"/>
              </a:ext>
            </a:extLst>
          </p:cNvPr>
          <p:cNvCxnSpPr>
            <a:cxnSpLocks/>
          </p:cNvCxnSpPr>
          <p:nvPr/>
        </p:nvCxnSpPr>
        <p:spPr>
          <a:xfrm flipV="1">
            <a:off x="3287972" y="596748"/>
            <a:ext cx="1935786" cy="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id="{9A549565-1DC3-1390-ADED-38539A9233E3}"/>
              </a:ext>
            </a:extLst>
          </p:cNvPr>
          <p:cNvCxnSpPr>
            <a:cxnSpLocks/>
          </p:cNvCxnSpPr>
          <p:nvPr/>
        </p:nvCxnSpPr>
        <p:spPr>
          <a:xfrm>
            <a:off x="7251796" y="566909"/>
            <a:ext cx="1842679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>
            <a:extLst>
              <a:ext uri="{FF2B5EF4-FFF2-40B4-BE49-F238E27FC236}">
                <a16:creationId xmlns:a16="http://schemas.microsoft.com/office/drawing/2014/main" id="{2FD0FD06-8FE8-0B42-3C1B-CD47B9BE6893}"/>
              </a:ext>
            </a:extLst>
          </p:cNvPr>
          <p:cNvSpPr txBox="1"/>
          <p:nvPr/>
        </p:nvSpPr>
        <p:spPr>
          <a:xfrm>
            <a:off x="3583778" y="319749"/>
            <a:ext cx="163998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ntrol fibroblasts</a:t>
            </a:r>
            <a:endParaRPr kumimoji="0" 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08F8AE76-7B8B-471C-BA5A-F0C4825455F3}"/>
              </a:ext>
            </a:extLst>
          </p:cNvPr>
          <p:cNvSpPr txBox="1"/>
          <p:nvPr/>
        </p:nvSpPr>
        <p:spPr>
          <a:xfrm>
            <a:off x="7464729" y="283827"/>
            <a:ext cx="1629746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Control fibroblasts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9CA27C12-CA56-6465-8E96-B4831A293FC2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19194" t="32985" r="12566"/>
          <a:stretch/>
        </p:blipFill>
        <p:spPr>
          <a:xfrm>
            <a:off x="2078341" y="711794"/>
            <a:ext cx="7829933" cy="6146206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5490CCE2-D6B5-A023-7356-EF59D7BC7FBD}"/>
              </a:ext>
            </a:extLst>
          </p:cNvPr>
          <p:cNvSpPr txBox="1"/>
          <p:nvPr/>
        </p:nvSpPr>
        <p:spPr>
          <a:xfrm>
            <a:off x="1590633" y="1015965"/>
            <a:ext cx="6062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50-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E8510DBC-B7F2-11C9-43D1-77F78FF987AE}"/>
              </a:ext>
            </a:extLst>
          </p:cNvPr>
          <p:cNvSpPr txBox="1"/>
          <p:nvPr/>
        </p:nvSpPr>
        <p:spPr>
          <a:xfrm>
            <a:off x="1590633" y="1385297"/>
            <a:ext cx="6062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50-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CD2EC18F-6753-59DE-9626-BD3F9EF04E99}"/>
              </a:ext>
            </a:extLst>
          </p:cNvPr>
          <p:cNvSpPr txBox="1"/>
          <p:nvPr/>
        </p:nvSpPr>
        <p:spPr>
          <a:xfrm>
            <a:off x="1595029" y="1795604"/>
            <a:ext cx="6062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00-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DA3CB149-B5BB-31C2-E769-1DAD4E1DF920}"/>
              </a:ext>
            </a:extLst>
          </p:cNvPr>
          <p:cNvSpPr txBox="1"/>
          <p:nvPr/>
        </p:nvSpPr>
        <p:spPr>
          <a:xfrm>
            <a:off x="1707653" y="2164936"/>
            <a:ext cx="489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75-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35E47FAA-6529-ED62-C8ED-65B91BACB63A}"/>
              </a:ext>
            </a:extLst>
          </p:cNvPr>
          <p:cNvSpPr txBox="1"/>
          <p:nvPr/>
        </p:nvSpPr>
        <p:spPr>
          <a:xfrm>
            <a:off x="1707653" y="3082158"/>
            <a:ext cx="489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50-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906D2A5F-AB8F-E382-6BCF-02D7BE9DDB83}"/>
              </a:ext>
            </a:extLst>
          </p:cNvPr>
          <p:cNvSpPr txBox="1"/>
          <p:nvPr/>
        </p:nvSpPr>
        <p:spPr>
          <a:xfrm>
            <a:off x="1707653" y="3764999"/>
            <a:ext cx="489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37-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E2AF714D-00AD-F6C8-D069-0040DB945C10}"/>
              </a:ext>
            </a:extLst>
          </p:cNvPr>
          <p:cNvSpPr txBox="1"/>
          <p:nvPr/>
        </p:nvSpPr>
        <p:spPr>
          <a:xfrm>
            <a:off x="1718257" y="4947402"/>
            <a:ext cx="489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5-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A29A96A1-EB8C-8C41-8976-558535F5935F}"/>
              </a:ext>
            </a:extLst>
          </p:cNvPr>
          <p:cNvSpPr txBox="1"/>
          <p:nvPr/>
        </p:nvSpPr>
        <p:spPr>
          <a:xfrm>
            <a:off x="1707653" y="5584600"/>
            <a:ext cx="489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0-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FC7194A-047E-3332-8315-FE6EC9907A75}"/>
              </a:ext>
            </a:extLst>
          </p:cNvPr>
          <p:cNvSpPr txBox="1"/>
          <p:nvPr/>
        </p:nvSpPr>
        <p:spPr>
          <a:xfrm>
            <a:off x="1571639" y="453447"/>
            <a:ext cx="5421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kDa</a:t>
            </a: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DE0B3106-E376-9E5F-3F85-0EEA77A8C338}"/>
              </a:ext>
            </a:extLst>
          </p:cNvPr>
          <p:cNvSpPr/>
          <p:nvPr/>
        </p:nvSpPr>
        <p:spPr>
          <a:xfrm>
            <a:off x="2474050" y="3164882"/>
            <a:ext cx="7110294" cy="82923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0BAF5B69-1381-175E-58E6-92285A0BFBD4}"/>
              </a:ext>
            </a:extLst>
          </p:cNvPr>
          <p:cNvSpPr txBox="1"/>
          <p:nvPr/>
        </p:nvSpPr>
        <p:spPr>
          <a:xfrm>
            <a:off x="9675558" y="3395667"/>
            <a:ext cx="1324538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itrate synthase</a:t>
            </a:r>
            <a:endParaRPr kumimoji="0" lang="en-US" sz="1800" b="1" i="0" u="none" strike="noStrike" kern="1200" cap="none" spc="0" normalizeH="0" baseline="0" noProof="0" dirty="0">
              <a:ln>
                <a:noFill/>
              </a:ln>
              <a:solidFill>
                <a:srgbClr val="FF0000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7507416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 descr="A close-up of a line&#10;&#10;AI-generated content may be incorrect.">
            <a:extLst>
              <a:ext uri="{FF2B5EF4-FFF2-40B4-BE49-F238E27FC236}">
                <a16:creationId xmlns:a16="http://schemas.microsoft.com/office/drawing/2014/main" id="{DC5F7102-6F33-39E9-8845-30C4408613E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0594" r="10948" b="1538"/>
          <a:stretch/>
        </p:blipFill>
        <p:spPr>
          <a:xfrm>
            <a:off x="449865" y="1133766"/>
            <a:ext cx="10823185" cy="5621875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EB44B005-60CF-BD55-7049-4930A59B6DCE}"/>
              </a:ext>
            </a:extLst>
          </p:cNvPr>
          <p:cNvSpPr txBox="1"/>
          <p:nvPr/>
        </p:nvSpPr>
        <p:spPr>
          <a:xfrm>
            <a:off x="2084004" y="306104"/>
            <a:ext cx="1131264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oband 1</a:t>
            </a:r>
            <a:endParaRPr kumimoji="0" 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34E6959B-F58C-B221-F940-DC546C7B85F3}"/>
              </a:ext>
            </a:extLst>
          </p:cNvPr>
          <p:cNvSpPr txBox="1"/>
          <p:nvPr/>
        </p:nvSpPr>
        <p:spPr>
          <a:xfrm>
            <a:off x="5976493" y="315447"/>
            <a:ext cx="1046415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Proband 4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2AADB4A8-CD26-7F2F-4550-A1A9AC98677D}"/>
              </a:ext>
            </a:extLst>
          </p:cNvPr>
          <p:cNvSpPr txBox="1"/>
          <p:nvPr/>
        </p:nvSpPr>
        <p:spPr>
          <a:xfrm>
            <a:off x="5157818" y="315447"/>
            <a:ext cx="102317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Proband 6</a:t>
            </a:r>
          </a:p>
        </p:txBody>
      </p:sp>
      <p:cxnSp>
        <p:nvCxnSpPr>
          <p:cNvPr id="5" name="Straight Connector 4">
            <a:extLst>
              <a:ext uri="{FF2B5EF4-FFF2-40B4-BE49-F238E27FC236}">
                <a16:creationId xmlns:a16="http://schemas.microsoft.com/office/drawing/2014/main" id="{74F49884-0743-02A1-2C5F-CA442C272074}"/>
              </a:ext>
            </a:extLst>
          </p:cNvPr>
          <p:cNvCxnSpPr>
            <a:cxnSpLocks/>
          </p:cNvCxnSpPr>
          <p:nvPr/>
        </p:nvCxnSpPr>
        <p:spPr>
          <a:xfrm flipV="1">
            <a:off x="3028665" y="583100"/>
            <a:ext cx="1935786" cy="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id="{8DE86C14-7A05-0A6E-306B-7608D575820A}"/>
              </a:ext>
            </a:extLst>
          </p:cNvPr>
          <p:cNvCxnSpPr>
            <a:cxnSpLocks/>
          </p:cNvCxnSpPr>
          <p:nvPr/>
        </p:nvCxnSpPr>
        <p:spPr>
          <a:xfrm>
            <a:off x="6992489" y="553261"/>
            <a:ext cx="1842679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>
            <a:extLst>
              <a:ext uri="{FF2B5EF4-FFF2-40B4-BE49-F238E27FC236}">
                <a16:creationId xmlns:a16="http://schemas.microsoft.com/office/drawing/2014/main" id="{9F50D145-8AA3-2127-6D9B-7502BB42143E}"/>
              </a:ext>
            </a:extLst>
          </p:cNvPr>
          <p:cNvSpPr txBox="1"/>
          <p:nvPr/>
        </p:nvSpPr>
        <p:spPr>
          <a:xfrm>
            <a:off x="3324471" y="306101"/>
            <a:ext cx="163998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ntrol fibroblasts</a:t>
            </a:r>
            <a:endParaRPr kumimoji="0" 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411DA29C-4C6D-61D3-3575-BB9D8A083D3E}"/>
              </a:ext>
            </a:extLst>
          </p:cNvPr>
          <p:cNvSpPr txBox="1"/>
          <p:nvPr/>
        </p:nvSpPr>
        <p:spPr>
          <a:xfrm>
            <a:off x="7205422" y="270179"/>
            <a:ext cx="1629746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Control fibroblasts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C2C1122F-F4C5-94D6-5939-8FAB6FF1B2C6}"/>
              </a:ext>
            </a:extLst>
          </p:cNvPr>
          <p:cNvSpPr txBox="1"/>
          <p:nvPr/>
        </p:nvSpPr>
        <p:spPr>
          <a:xfrm>
            <a:off x="1877467" y="1049956"/>
            <a:ext cx="6062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50-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A555A84-2FFC-A0E8-2DE2-26F8BE53EDAF}"/>
              </a:ext>
            </a:extLst>
          </p:cNvPr>
          <p:cNvSpPr txBox="1"/>
          <p:nvPr/>
        </p:nvSpPr>
        <p:spPr>
          <a:xfrm>
            <a:off x="1877467" y="1419288"/>
            <a:ext cx="6062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50-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DD9F538E-820D-9045-3A8A-20FA97D40AA5}"/>
              </a:ext>
            </a:extLst>
          </p:cNvPr>
          <p:cNvSpPr txBox="1"/>
          <p:nvPr/>
        </p:nvSpPr>
        <p:spPr>
          <a:xfrm>
            <a:off x="1881863" y="1829595"/>
            <a:ext cx="6062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00-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B36417CE-DAFE-7A6F-BCD8-01422780A614}"/>
              </a:ext>
            </a:extLst>
          </p:cNvPr>
          <p:cNvSpPr txBox="1"/>
          <p:nvPr/>
        </p:nvSpPr>
        <p:spPr>
          <a:xfrm>
            <a:off x="1994487" y="2198927"/>
            <a:ext cx="489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75-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7EEA68C1-A46C-99CC-3386-13EA3C47D309}"/>
              </a:ext>
            </a:extLst>
          </p:cNvPr>
          <p:cNvSpPr txBox="1"/>
          <p:nvPr/>
        </p:nvSpPr>
        <p:spPr>
          <a:xfrm>
            <a:off x="1994487" y="3116149"/>
            <a:ext cx="489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50-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7B5C3261-F5F7-998B-FD7C-9F1B20463DA3}"/>
              </a:ext>
            </a:extLst>
          </p:cNvPr>
          <p:cNvSpPr txBox="1"/>
          <p:nvPr/>
        </p:nvSpPr>
        <p:spPr>
          <a:xfrm>
            <a:off x="1994487" y="3798990"/>
            <a:ext cx="489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37-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ABAD9E63-A697-A005-777A-8D4C6331426D}"/>
              </a:ext>
            </a:extLst>
          </p:cNvPr>
          <p:cNvSpPr txBox="1"/>
          <p:nvPr/>
        </p:nvSpPr>
        <p:spPr>
          <a:xfrm>
            <a:off x="2005091" y="4981393"/>
            <a:ext cx="489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5-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F42A52AC-52C8-52D5-FD99-A177BA2ACDCB}"/>
              </a:ext>
            </a:extLst>
          </p:cNvPr>
          <p:cNvSpPr txBox="1"/>
          <p:nvPr/>
        </p:nvSpPr>
        <p:spPr>
          <a:xfrm>
            <a:off x="1994487" y="5618591"/>
            <a:ext cx="489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0-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1AED72C8-99DD-7FD6-EA61-66C5D9362A92}"/>
              </a:ext>
            </a:extLst>
          </p:cNvPr>
          <p:cNvSpPr txBox="1"/>
          <p:nvPr/>
        </p:nvSpPr>
        <p:spPr>
          <a:xfrm>
            <a:off x="1858473" y="487438"/>
            <a:ext cx="5421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kDa</a:t>
            </a:r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61C2DB48-2B86-D982-CFFB-36FE227F7702}"/>
              </a:ext>
            </a:extLst>
          </p:cNvPr>
          <p:cNvSpPr/>
          <p:nvPr/>
        </p:nvSpPr>
        <p:spPr>
          <a:xfrm>
            <a:off x="2443140" y="5069381"/>
            <a:ext cx="7110294" cy="82923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2C569DE3-8A2F-730D-A583-92F9AE71A72C}"/>
              </a:ext>
            </a:extLst>
          </p:cNvPr>
          <p:cNvSpPr txBox="1"/>
          <p:nvPr/>
        </p:nvSpPr>
        <p:spPr>
          <a:xfrm>
            <a:off x="9556408" y="5249259"/>
            <a:ext cx="118394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1" i="0" u="none" strike="noStrike" kern="1200" cap="none" spc="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ATP5PO</a:t>
            </a:r>
          </a:p>
        </p:txBody>
      </p:sp>
    </p:spTree>
    <p:extLst>
      <p:ext uri="{BB962C8B-B14F-4D97-AF65-F5344CB8AC3E}">
        <p14:creationId xmlns:p14="http://schemas.microsoft.com/office/powerpoint/2010/main" val="125849247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black lines on a white background&#10;&#10;AI-generated content may be incorrect.">
            <a:extLst>
              <a:ext uri="{FF2B5EF4-FFF2-40B4-BE49-F238E27FC236}">
                <a16:creationId xmlns:a16="http://schemas.microsoft.com/office/drawing/2014/main" id="{4508EAF4-1BE2-14BD-4945-DA46E9AC43E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874" t="38188"/>
          <a:stretch/>
        </p:blipFill>
        <p:spPr>
          <a:xfrm>
            <a:off x="1244591" y="1196503"/>
            <a:ext cx="9070504" cy="5391318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54393247-D691-1DF1-F2A5-2101C495A3C2}"/>
              </a:ext>
            </a:extLst>
          </p:cNvPr>
          <p:cNvSpPr txBox="1"/>
          <p:nvPr/>
        </p:nvSpPr>
        <p:spPr>
          <a:xfrm>
            <a:off x="2084004" y="306104"/>
            <a:ext cx="1131264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oband 1</a:t>
            </a:r>
            <a:endParaRPr kumimoji="0" 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9C5D1242-DD3C-EC10-189D-6851F2E8E815}"/>
              </a:ext>
            </a:extLst>
          </p:cNvPr>
          <p:cNvSpPr txBox="1"/>
          <p:nvPr/>
        </p:nvSpPr>
        <p:spPr>
          <a:xfrm>
            <a:off x="5976493" y="315447"/>
            <a:ext cx="1046415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Proband 4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5A3BB54A-BBB2-176F-1014-95B72177BCAB}"/>
              </a:ext>
            </a:extLst>
          </p:cNvPr>
          <p:cNvSpPr txBox="1"/>
          <p:nvPr/>
        </p:nvSpPr>
        <p:spPr>
          <a:xfrm>
            <a:off x="5157818" y="315447"/>
            <a:ext cx="102317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Proband 6</a:t>
            </a:r>
          </a:p>
        </p:txBody>
      </p: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BE9A5090-4EFA-DDD8-CFBE-A9EB33653EBA}"/>
              </a:ext>
            </a:extLst>
          </p:cNvPr>
          <p:cNvCxnSpPr>
            <a:cxnSpLocks/>
          </p:cNvCxnSpPr>
          <p:nvPr/>
        </p:nvCxnSpPr>
        <p:spPr>
          <a:xfrm flipV="1">
            <a:off x="3028665" y="583100"/>
            <a:ext cx="1935786" cy="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F2EF3DF0-279A-5ED5-065B-2AE8E93949D4}"/>
              </a:ext>
            </a:extLst>
          </p:cNvPr>
          <p:cNvCxnSpPr>
            <a:cxnSpLocks/>
          </p:cNvCxnSpPr>
          <p:nvPr/>
        </p:nvCxnSpPr>
        <p:spPr>
          <a:xfrm>
            <a:off x="6992489" y="553261"/>
            <a:ext cx="1842679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>
            <a:extLst>
              <a:ext uri="{FF2B5EF4-FFF2-40B4-BE49-F238E27FC236}">
                <a16:creationId xmlns:a16="http://schemas.microsoft.com/office/drawing/2014/main" id="{CD19ED70-E9FF-2DED-EA35-4D53F159ECDD}"/>
              </a:ext>
            </a:extLst>
          </p:cNvPr>
          <p:cNvSpPr txBox="1"/>
          <p:nvPr/>
        </p:nvSpPr>
        <p:spPr>
          <a:xfrm>
            <a:off x="3324471" y="306101"/>
            <a:ext cx="163998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ntrol fibroblasts</a:t>
            </a:r>
            <a:endParaRPr kumimoji="0" 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A8A104C-3225-5E82-3393-495927988AE2}"/>
              </a:ext>
            </a:extLst>
          </p:cNvPr>
          <p:cNvSpPr txBox="1"/>
          <p:nvPr/>
        </p:nvSpPr>
        <p:spPr>
          <a:xfrm>
            <a:off x="7205422" y="270179"/>
            <a:ext cx="1629746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Control fibroblasts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B5B0D12-15D5-8696-7279-9AA0584CD0EE}"/>
              </a:ext>
            </a:extLst>
          </p:cNvPr>
          <p:cNvSpPr txBox="1"/>
          <p:nvPr/>
        </p:nvSpPr>
        <p:spPr>
          <a:xfrm>
            <a:off x="9296386" y="2748145"/>
            <a:ext cx="150568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b="1" i="0" u="none" strike="noStrike" kern="1200" cap="none" spc="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ATP5F1A</a:t>
            </a: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6E5DB7CB-7109-5123-D657-B17674B7B6BB}"/>
              </a:ext>
            </a:extLst>
          </p:cNvPr>
          <p:cNvSpPr/>
          <p:nvPr/>
        </p:nvSpPr>
        <p:spPr>
          <a:xfrm>
            <a:off x="2057857" y="2670131"/>
            <a:ext cx="7198703" cy="52536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B4C9E1FA-6D98-52A3-B969-FD2C41AE9985}"/>
              </a:ext>
            </a:extLst>
          </p:cNvPr>
          <p:cNvSpPr txBox="1"/>
          <p:nvPr/>
        </p:nvSpPr>
        <p:spPr>
          <a:xfrm>
            <a:off x="1451601" y="969742"/>
            <a:ext cx="6062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50-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DBF219AA-0E6A-9026-F26B-5AA570FF79A5}"/>
              </a:ext>
            </a:extLst>
          </p:cNvPr>
          <p:cNvSpPr txBox="1"/>
          <p:nvPr/>
        </p:nvSpPr>
        <p:spPr>
          <a:xfrm>
            <a:off x="1451601" y="1339074"/>
            <a:ext cx="6062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50-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8057A159-1721-7141-2BB0-5CB089CBC7EC}"/>
              </a:ext>
            </a:extLst>
          </p:cNvPr>
          <p:cNvSpPr txBox="1"/>
          <p:nvPr/>
        </p:nvSpPr>
        <p:spPr>
          <a:xfrm>
            <a:off x="1455997" y="1749381"/>
            <a:ext cx="6062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00-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AFB069A6-645B-F812-0B95-9F1D8F6078A3}"/>
              </a:ext>
            </a:extLst>
          </p:cNvPr>
          <p:cNvSpPr txBox="1"/>
          <p:nvPr/>
        </p:nvSpPr>
        <p:spPr>
          <a:xfrm>
            <a:off x="1568621" y="2118713"/>
            <a:ext cx="489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75-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A729E030-F2A6-114B-0055-260629EF9721}"/>
              </a:ext>
            </a:extLst>
          </p:cNvPr>
          <p:cNvSpPr txBox="1"/>
          <p:nvPr/>
        </p:nvSpPr>
        <p:spPr>
          <a:xfrm>
            <a:off x="1568621" y="3035935"/>
            <a:ext cx="489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50-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45016AEE-8FAB-FC01-1FDC-25CA6FC02AA8}"/>
              </a:ext>
            </a:extLst>
          </p:cNvPr>
          <p:cNvSpPr txBox="1"/>
          <p:nvPr/>
        </p:nvSpPr>
        <p:spPr>
          <a:xfrm>
            <a:off x="1568621" y="3718776"/>
            <a:ext cx="489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37-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929E3DB4-995A-16BB-0C11-615C1BEE1BD1}"/>
              </a:ext>
            </a:extLst>
          </p:cNvPr>
          <p:cNvSpPr txBox="1"/>
          <p:nvPr/>
        </p:nvSpPr>
        <p:spPr>
          <a:xfrm>
            <a:off x="1579225" y="4901179"/>
            <a:ext cx="489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5-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4FFBD6F7-F94D-1D77-3A7E-BF470C545C2A}"/>
              </a:ext>
            </a:extLst>
          </p:cNvPr>
          <p:cNvSpPr txBox="1"/>
          <p:nvPr/>
        </p:nvSpPr>
        <p:spPr>
          <a:xfrm>
            <a:off x="1568621" y="5538377"/>
            <a:ext cx="489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0-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0107043A-D6C8-040B-0872-50004C6E5106}"/>
              </a:ext>
            </a:extLst>
          </p:cNvPr>
          <p:cNvSpPr txBox="1"/>
          <p:nvPr/>
        </p:nvSpPr>
        <p:spPr>
          <a:xfrm>
            <a:off x="1432607" y="407224"/>
            <a:ext cx="5421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kDa</a:t>
            </a:r>
          </a:p>
        </p:txBody>
      </p:sp>
    </p:spTree>
    <p:extLst>
      <p:ext uri="{BB962C8B-B14F-4D97-AF65-F5344CB8AC3E}">
        <p14:creationId xmlns:p14="http://schemas.microsoft.com/office/powerpoint/2010/main" val="264343377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D50B0BC5-B6CF-E9B6-29B0-838A18048CB7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4165"/>
          <a:stretch/>
        </p:blipFill>
        <p:spPr>
          <a:xfrm>
            <a:off x="1824715" y="906232"/>
            <a:ext cx="7631269" cy="5867400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5CC7A77D-CCD1-193C-7EC6-B900BCCC7A2E}"/>
              </a:ext>
            </a:extLst>
          </p:cNvPr>
          <p:cNvSpPr txBox="1"/>
          <p:nvPr/>
        </p:nvSpPr>
        <p:spPr>
          <a:xfrm>
            <a:off x="3005891" y="214025"/>
            <a:ext cx="61802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embrane overlay for molecular weight sizing for western blots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B5FB2B44-D493-EF7E-FE26-D927BFA91019}"/>
              </a:ext>
            </a:extLst>
          </p:cNvPr>
          <p:cNvSpPr txBox="1"/>
          <p:nvPr/>
        </p:nvSpPr>
        <p:spPr>
          <a:xfrm>
            <a:off x="1218459" y="1383133"/>
            <a:ext cx="6062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50-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794193F2-D022-AF02-5B03-DEA2DBE94216}"/>
              </a:ext>
            </a:extLst>
          </p:cNvPr>
          <p:cNvSpPr txBox="1"/>
          <p:nvPr/>
        </p:nvSpPr>
        <p:spPr>
          <a:xfrm>
            <a:off x="1218459" y="1752465"/>
            <a:ext cx="6062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50-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3108F2F-9D5C-3401-8CFE-9BD29C2AFDD1}"/>
              </a:ext>
            </a:extLst>
          </p:cNvPr>
          <p:cNvSpPr txBox="1"/>
          <p:nvPr/>
        </p:nvSpPr>
        <p:spPr>
          <a:xfrm>
            <a:off x="1222855" y="2162772"/>
            <a:ext cx="6062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00-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A84F778-62E2-AB10-A00C-9AEC91F4D34F}"/>
              </a:ext>
            </a:extLst>
          </p:cNvPr>
          <p:cNvSpPr txBox="1"/>
          <p:nvPr/>
        </p:nvSpPr>
        <p:spPr>
          <a:xfrm>
            <a:off x="1335479" y="2532104"/>
            <a:ext cx="489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75-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9676ABF-52C7-E464-63FA-1FA6C89608DD}"/>
              </a:ext>
            </a:extLst>
          </p:cNvPr>
          <p:cNvSpPr txBox="1"/>
          <p:nvPr/>
        </p:nvSpPr>
        <p:spPr>
          <a:xfrm>
            <a:off x="1335479" y="3449326"/>
            <a:ext cx="489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50-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0EBCF743-1379-7E70-7E61-E19A6D1E59B0}"/>
              </a:ext>
            </a:extLst>
          </p:cNvPr>
          <p:cNvSpPr txBox="1"/>
          <p:nvPr/>
        </p:nvSpPr>
        <p:spPr>
          <a:xfrm>
            <a:off x="1335479" y="4132167"/>
            <a:ext cx="489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37-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5B236054-99DF-7F06-3FDB-2F386281602A}"/>
              </a:ext>
            </a:extLst>
          </p:cNvPr>
          <p:cNvSpPr txBox="1"/>
          <p:nvPr/>
        </p:nvSpPr>
        <p:spPr>
          <a:xfrm>
            <a:off x="1346083" y="5314570"/>
            <a:ext cx="489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5-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58C9B87E-6731-AA26-187B-56910AD669EA}"/>
              </a:ext>
            </a:extLst>
          </p:cNvPr>
          <p:cNvSpPr txBox="1"/>
          <p:nvPr/>
        </p:nvSpPr>
        <p:spPr>
          <a:xfrm>
            <a:off x="1344995" y="5905852"/>
            <a:ext cx="489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0-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6A72487E-9429-FBD1-7B0F-077F4FA027BE}"/>
              </a:ext>
            </a:extLst>
          </p:cNvPr>
          <p:cNvSpPr txBox="1"/>
          <p:nvPr/>
        </p:nvSpPr>
        <p:spPr>
          <a:xfrm>
            <a:off x="1199465" y="820615"/>
            <a:ext cx="5421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kDa</a:t>
            </a:r>
          </a:p>
        </p:txBody>
      </p:sp>
    </p:spTree>
    <p:extLst>
      <p:ext uri="{BB962C8B-B14F-4D97-AF65-F5344CB8AC3E}">
        <p14:creationId xmlns:p14="http://schemas.microsoft.com/office/powerpoint/2010/main" val="22022545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22</TotalTime>
  <Words>116</Words>
  <Application>Microsoft Office PowerPoint</Application>
  <PresentationFormat>Widescreen</PresentationFormat>
  <Paragraphs>81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Children's Hospital Colorado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riederich, Marisa</dc:creator>
  <cp:lastModifiedBy>Friederich, Marisa</cp:lastModifiedBy>
  <cp:revision>10</cp:revision>
  <dcterms:created xsi:type="dcterms:W3CDTF">2024-09-27T14:04:53Z</dcterms:created>
  <dcterms:modified xsi:type="dcterms:W3CDTF">2025-05-07T00:28:06Z</dcterms:modified>
</cp:coreProperties>
</file>